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80C2EA-8A8F-4139-82A2-41D688C6C36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456671-8B1F-440F-A1CD-3D5FFFC55CA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82F6F7-85B8-4C68-AE5A-FFEA32EBBED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54BFC5-8E8E-4A69-985B-128EACA1B94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8F33C3-DEAC-46B8-9E28-C58CAFA1F0B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679169-F9CE-4B5E-9C1F-3E4144AB61B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11CE0B-C334-4DCE-A4E1-BDF094BF666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91A473-9165-4B0A-A252-1F72549E5F1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AD8952-1CA0-463D-A77D-86F8BC8785F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940550-2D7F-4C8D-9B9D-A565AFC9B2C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BF2731-F271-41C5-B611-964A760CA0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476EF1-8B27-4D22-A96A-A5998BF0F38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DA29A01-0858-41D9-B9FF-8E61BCC389DD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54440" y="6369120"/>
            <a:ext cx="777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Fig. S2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2" name="export" descr=""/>
          <p:cNvPicPr/>
          <p:nvPr/>
        </p:nvPicPr>
        <p:blipFill>
          <a:blip r:embed="rId1"/>
          <a:stretch/>
        </p:blipFill>
        <p:spPr>
          <a:xfrm>
            <a:off x="76320" y="685800"/>
            <a:ext cx="8915400" cy="522756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3900600" y="3657600"/>
            <a:ext cx="2188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3300"/>
                </a:solidFill>
                <a:latin typeface="Times New Roman"/>
              </a:rPr>
              <a:t>●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"/>
          <p:cNvSpPr/>
          <p:nvPr/>
        </p:nvSpPr>
        <p:spPr>
          <a:xfrm>
            <a:off x="228600" y="228600"/>
            <a:ext cx="861048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Times New Roman"/>
              </a:rPr>
              <a:t>Fig. S2</a:t>
            </a:r>
            <a:r>
              <a:rPr b="1" lang="ja-JP" sz="12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1" lang="ja-JP" sz="12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Population snapshot of </a:t>
            </a:r>
            <a:r>
              <a:rPr b="1" i="1" lang="ja-JP" sz="12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Microcystis aeruginosa</a:t>
            </a:r>
            <a:r>
              <a:rPr b="1" lang="ja-JP" sz="12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group</a:t>
            </a:r>
            <a:r>
              <a:rPr b="1" lang="ja-JP" sz="12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G.</a:t>
            </a:r>
            <a:r>
              <a:rPr b="0" lang="ja-JP" sz="12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eBURST ver. 3 (available at http://eburst.mlst.net/default.asp) [27] was used to illustrate the snapshot. Each circle indicates a distinct ST accompanied by the corresponding number. Circle size is proportional to the abundance of isolates of that ST.</a:t>
            </a:r>
            <a:r>
              <a:rPr b="0" lang="ja-JP" sz="1200" spc="-1" strike="noStrike">
                <a:solidFill>
                  <a:srgbClr val="ff0000"/>
                </a:solidFill>
                <a:latin typeface="Times New Roman"/>
                <a:ea typeface="ＭＳ 明朝"/>
              </a:rPr>
              <a:t> </a:t>
            </a:r>
            <a:r>
              <a:rPr b="0" lang="ja-JP" sz="12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Pairs of circles, which together represent a single locus variant (SLV; the ST differs at only one of the seven alleles), are connected by a line. The group of STs connected by lines form a “clonal complex.” The red circle (ST116) indicates a putative founder genotype of the clonal complex. To avoid the effect of biased isolation of strains, only a single ST was included to represent more than two strains isolated from the same place and time. Note that analysis without the highly polymorphic locus </a:t>
            </a:r>
            <a:r>
              <a:rPr b="0" i="1" lang="ja-JP" sz="12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glnA</a:t>
            </a:r>
            <a:r>
              <a:rPr b="0" lang="ja-JP" sz="12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gives essentially the same picture (data not shown).</a:t>
            </a:r>
            <a:r>
              <a:rPr b="0" lang="ja-JP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1-20T06:47:08Z</dcterms:created>
  <dc:creator>YT</dc:creator>
  <dc:description/>
  <dc:language>en-US</dc:language>
  <cp:lastModifiedBy>YT</cp:lastModifiedBy>
  <dcterms:modified xsi:type="dcterms:W3CDTF">2011-01-07T08:26:06Z</dcterms:modified>
  <cp:revision>35</cp:revision>
  <dc:subject/>
  <dc:title>PowerPoint プレゼンテーション</dc:title>
</cp:coreProperties>
</file>